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6" r:id="rId2"/>
  </p:sldIdLst>
  <p:sldSz cx="12192000" cy="6858000"/>
  <p:notesSz cx="6858000" cy="9144000"/>
  <p:embeddedFontLst>
    <p:embeddedFont>
      <p:font typeface="Calibri Light" panose="020F0302020204030204" pitchFamily="34" charset="0"/>
      <p:regular r:id="rId3"/>
      <p:italic r:id="rId4"/>
    </p:embeddedFont>
    <p:embeddedFont>
      <p:font typeface="Calibri" panose="020F0502020204030204" pitchFamily="34" charset="0"/>
      <p:regular r:id="rId5"/>
      <p:bold r:id="rId6"/>
      <p:italic r:id="rId7"/>
      <p:boldItalic r:id="rId8"/>
    </p:embeddedFont>
  </p:embeddedFontLst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334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91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98434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02048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877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57573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97087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75357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54668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07584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85292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05150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83192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EC258-B6E9-4911-9A21-BF4093E3F666}" type="datetimeFigureOut">
              <a:rPr lang="nb-NO" smtClean="0"/>
              <a:t>30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3E1F8-C7EA-4B09-945C-E9941FC959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16026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14034" y="641056"/>
            <a:ext cx="3280033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jects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ttending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screening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sit</a:t>
            </a:r>
            <a:endParaRPr lang="nb-NO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251</a:t>
            </a:r>
            <a:endParaRPr lang="nb-NO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727379" y="621778"/>
            <a:ext cx="3345084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FH-subjects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ticipating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in</a:t>
            </a:r>
          </a:p>
          <a:p>
            <a:pPr algn="ctr"/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original studies</a:t>
            </a:r>
          </a:p>
          <a:p>
            <a:pPr algn="ctr"/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215</a:t>
            </a:r>
            <a:endParaRPr lang="nb-NO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32898" y="2759662"/>
            <a:ext cx="3833101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23)</a:t>
            </a:r>
          </a:p>
          <a:p>
            <a:pPr lvl="1"/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ssing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FFQ: </a:t>
            </a:r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11</a:t>
            </a:r>
            <a:endParaRPr lang="nb-NO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Energy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ake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&gt;20 000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J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1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414034" y="4593954"/>
            <a:ext cx="3280033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in cross-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ctional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nb-NO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228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728842" y="2621162"/>
            <a:ext cx="3704860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10)</a:t>
            </a:r>
          </a:p>
          <a:p>
            <a:pPr lvl="1"/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ssing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FFQ: </a:t>
            </a:r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  <a:endParaRPr lang="nb-NO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Energy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ake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&lt;4000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J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  <a:p>
            <a:pPr lvl="1"/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Energy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ake</a:t>
            </a:r>
            <a:r>
              <a:rPr lang="nb-NO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&gt;20 000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J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639791" y="4586639"/>
            <a:ext cx="3432672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smtClean="0">
                <a:latin typeface="Arial" panose="020B0604020202020204" pitchFamily="34" charset="0"/>
                <a:cs typeface="Arial" panose="020B0604020202020204" pitchFamily="34" charset="0"/>
              </a:rPr>
              <a:t>HeFH-participants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in cross-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ctional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nb-NO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b-NO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nb-NO" dirty="0" smtClean="0">
                <a:latin typeface="Arial" panose="020B0604020202020204" pitchFamily="34" charset="0"/>
                <a:cs typeface="Arial" panose="020B0604020202020204" pitchFamily="34" charset="0"/>
              </a:rPr>
              <a:t> 205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5377363" y="1564386"/>
            <a:ext cx="5" cy="302956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7025077" y="1545108"/>
            <a:ext cx="1215" cy="3048846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H="1">
            <a:off x="4673600" y="3221327"/>
            <a:ext cx="70376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rot="10800000" flipH="1">
            <a:off x="7025077" y="3228221"/>
            <a:ext cx="70376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40169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75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 Light</vt:lpstr>
      <vt:lpstr>Calibri</vt:lpstr>
      <vt:lpstr>Office Theme</vt:lpstr>
      <vt:lpstr>PowerPoint Presentation</vt:lpstr>
    </vt:vector>
  </TitlesOfParts>
  <Company>Universitetet i Os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irin Brenna Løvheim</dc:creator>
  <cp:lastModifiedBy>Kirsten Bjørklund Holven</cp:lastModifiedBy>
  <cp:revision>44</cp:revision>
  <dcterms:created xsi:type="dcterms:W3CDTF">2023-01-10T06:57:52Z</dcterms:created>
  <dcterms:modified xsi:type="dcterms:W3CDTF">2024-09-30T09:57:19Z</dcterms:modified>
</cp:coreProperties>
</file>